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72D0C-88C4-4AE0-8538-6B924BC8A1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77A4D-1DFD-480D-88DC-83BD4C90F6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0B574-0E9C-4F9A-B393-CDF39913AC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1280A-C6D4-4702-90F7-D05A6B7189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4852B-182B-4A47-BA64-55CB9F27DE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AC2B7-B9AA-4499-93F6-D2605209EC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1FCCC-AD1F-46BF-9B4A-CCE4BC95F3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B0235-F096-4B84-91E4-D95BAB2F43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B8C1D-E138-474C-BF4E-8732097FE8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89EDF-E873-4C69-B11F-5F56A571B1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19470-B633-4AB2-B2F3-C29FA6F11C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61A67-9972-4046-8B68-E8A748D293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7D548C-68AC-48C3-8509-D54F235CD519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F809A6-0ED6-4037-B1CE-6BE5B812BF5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304920" y="304920"/>
            <a:ext cx="30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グラフ 31" descr=""/>
          <p:cNvPicPr/>
          <p:nvPr/>
        </p:nvPicPr>
        <p:blipFill>
          <a:blip r:embed="rId1"/>
          <a:stretch/>
        </p:blipFill>
        <p:spPr>
          <a:xfrm>
            <a:off x="1219320" y="1450800"/>
            <a:ext cx="4572000" cy="273708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4"/>
          <p:cNvSpPr/>
          <p:nvPr/>
        </p:nvSpPr>
        <p:spPr>
          <a:xfrm rot="16200000">
            <a:off x="-346320" y="2437200"/>
            <a:ext cx="243828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1-RTP cop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umbers (/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43"/>
          <p:cNvSpPr/>
          <p:nvPr/>
        </p:nvSpPr>
        <p:spPr>
          <a:xfrm>
            <a:off x="404640" y="4305240"/>
            <a:ext cx="60199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 S10. Effects of MAPK inhibitors on rVpr-induced L1-RTP. SB202190, SP600125 and PD98059 were used as p38, JNK or ERK inhibitors, respectively. HuH-7 cells were transfected with pER06R. MAPK inhibitors were added 1 h prior to addition of 10 ng/mL rVpr. L1-RTP was examined by qPCR analysis. The longitudinal axis shows L1-RTP copy numbers/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cells. One representative results of  three independent experiments are show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4:12Z</dcterms:modified>
  <cp:revision>1632</cp:revision>
  <dc:subject/>
  <dc:title>スライド 1</dc:title>
</cp:coreProperties>
</file>